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008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88090" y="4341114"/>
            <a:ext cx="1655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72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83968" y="434111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4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236296" y="434111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 flipH="1">
            <a:off x="333862" y="1648663"/>
            <a:ext cx="2608370" cy="26078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3432" y="1674671"/>
            <a:ext cx="2664712" cy="2579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3856" y="1682535"/>
            <a:ext cx="2599896" cy="25718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矩形 2"/>
          <p:cNvSpPr/>
          <p:nvPr/>
        </p:nvSpPr>
        <p:spPr>
          <a:xfrm>
            <a:off x="334125" y="4710446"/>
            <a:ext cx="81983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/>
              <a:t>Figure S7. GISH </a:t>
            </a:r>
            <a:r>
              <a:rPr lang="en-US" altLang="zh-CN" sz="1200" b="1" dirty="0"/>
              <a:t>analysis of partial derivatives</a:t>
            </a:r>
            <a:r>
              <a:rPr lang="en-US" altLang="zh-CN" sz="1200" b="1" dirty="0" smtClean="0"/>
              <a:t>. </a:t>
            </a:r>
            <a:r>
              <a:rPr lang="en-US" altLang="zh-CN" sz="1200" b="1" dirty="0"/>
              <a:t>GISH analysis showing chromosome composition with </a:t>
            </a:r>
            <a:r>
              <a:rPr lang="en-US" altLang="zh-CN" sz="1200" b="1" i="1" dirty="0"/>
              <a:t>A. </a:t>
            </a:r>
            <a:r>
              <a:rPr lang="en-US" altLang="zh-CN" sz="1200" b="1" i="1" dirty="0" err="1"/>
              <a:t>cristatum</a:t>
            </a:r>
            <a:r>
              <a:rPr lang="en-US" altLang="zh-CN" sz="1200" b="1" dirty="0"/>
              <a:t> genomic DNA as the probe and </a:t>
            </a:r>
            <a:r>
              <a:rPr lang="en-US" altLang="zh-CN" sz="1200" b="1" dirty="0" err="1"/>
              <a:t>Fukuho</a:t>
            </a:r>
            <a:r>
              <a:rPr lang="en-US" altLang="zh-CN" sz="1200" b="1" dirty="0"/>
              <a:t> DNA as blocker.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625965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32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12</cp:revision>
  <dcterms:created xsi:type="dcterms:W3CDTF">2017-08-24T08:13:13Z</dcterms:created>
  <dcterms:modified xsi:type="dcterms:W3CDTF">2017-08-25T09:02:27Z</dcterms:modified>
</cp:coreProperties>
</file>